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1" r:id="rId3"/>
    <p:sldId id="26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8" autoAdjust="0"/>
    <p:restoredTop sz="86766" autoAdjust="0"/>
  </p:normalViewPr>
  <p:slideViewPr>
    <p:cSldViewPr snapToGrid="0">
      <p:cViewPr varScale="1">
        <p:scale>
          <a:sx n="101" d="100"/>
          <a:sy n="101" d="100"/>
        </p:scale>
        <p:origin x="990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CFTAH 3000 RPM</c:v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U$6,Comparison!$U$8,Comparison!$U$10,Comparison!$U$12,Comparison!$U$15,Comparison!$U$17,Comparison!$U$19,Comparison!$U$21)</c:f>
              <c:numCache>
                <c:formatCode>0</c:formatCode>
                <c:ptCount val="8"/>
                <c:pt idx="0">
                  <c:v>12.935599999999999</c:v>
                </c:pt>
                <c:pt idx="1">
                  <c:v>-6.537300000000001</c:v>
                </c:pt>
                <c:pt idx="2">
                  <c:v>4.9505999999999997</c:v>
                </c:pt>
                <c:pt idx="3">
                  <c:v>1.1450000000000014</c:v>
                </c:pt>
                <c:pt idx="4">
                  <c:v>22.247900000000001</c:v>
                </c:pt>
                <c:pt idx="5">
                  <c:v>6.130000000000102E-2</c:v>
                </c:pt>
                <c:pt idx="6">
                  <c:v>12.562500000000002</c:v>
                </c:pt>
                <c:pt idx="7">
                  <c:v>8.84869999999999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C4B-47D3-922B-FF648F27B61F}"/>
            </c:ext>
          </c:extLst>
        </c:ser>
        <c:ser>
          <c:idx val="0"/>
          <c:order val="1"/>
          <c:tx>
            <c:v>CFTAH 3500 RPM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U$5,Comparison!$U$7,Comparison!$U$9,Comparison!$U$11,Comparison!$U$14,Comparison!$U$16,Comparison!$U$18,Comparison!$U$20)</c:f>
              <c:numCache>
                <c:formatCode>0</c:formatCode>
                <c:ptCount val="8"/>
                <c:pt idx="0">
                  <c:v>13.422099999999999</c:v>
                </c:pt>
                <c:pt idx="1">
                  <c:v>-9.1208999999999989</c:v>
                </c:pt>
                <c:pt idx="2">
                  <c:v>4.2416999999999998</c:v>
                </c:pt>
                <c:pt idx="3">
                  <c:v>1.0494000000000003</c:v>
                </c:pt>
                <c:pt idx="4">
                  <c:v>23.714700000000001</c:v>
                </c:pt>
                <c:pt idx="5">
                  <c:v>2.0471000000000004</c:v>
                </c:pt>
                <c:pt idx="6">
                  <c:v>16.208599999999997</c:v>
                </c:pt>
                <c:pt idx="7">
                  <c:v>11.204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C4B-47D3-922B-FF648F27B61F}"/>
            </c:ext>
          </c:extLst>
        </c:ser>
        <c:ser>
          <c:idx val="3"/>
          <c:order val="2"/>
          <c:tx>
            <c:v>UVAD 3200/2000 RPM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U$24,Comparison!$U$26,Comparison!$U$28,Comparison!$U$30,Comparison!$U$33,Comparison!$U$35,Comparison!$U$37,Comparison!$U$39)</c:f>
              <c:numCache>
                <c:formatCode>0</c:formatCode>
                <c:ptCount val="8"/>
                <c:pt idx="0">
                  <c:v>7.2941221430000009</c:v>
                </c:pt>
                <c:pt idx="1">
                  <c:v>-5.6325025640000002</c:v>
                </c:pt>
                <c:pt idx="2">
                  <c:v>3.7053729850000003</c:v>
                </c:pt>
                <c:pt idx="3">
                  <c:v>3.2103237459999994</c:v>
                </c:pt>
                <c:pt idx="4">
                  <c:v>8.0237634010000001</c:v>
                </c:pt>
                <c:pt idx="5">
                  <c:v>-4.7298362059999999</c:v>
                </c:pt>
                <c:pt idx="6">
                  <c:v>3.8454724099999993</c:v>
                </c:pt>
                <c:pt idx="7">
                  <c:v>3.630577413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C4B-47D3-922B-FF648F27B61F}"/>
            </c:ext>
          </c:extLst>
        </c:ser>
        <c:ser>
          <c:idx val="2"/>
          <c:order val="3"/>
          <c:tx>
            <c:v>UVAD 3800/2600 RPM</c:v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U$23,Comparison!$U$25,Comparison!$U$27,Comparison!$U$29,Comparison!$U$32,Comparison!$U$34,Comparison!$U$36,Comparison!$U$38)</c:f>
              <c:numCache>
                <c:formatCode>0</c:formatCode>
                <c:ptCount val="8"/>
                <c:pt idx="0">
                  <c:v>8.9276242450000005</c:v>
                </c:pt>
                <c:pt idx="1">
                  <c:v>-0.95128409160000005</c:v>
                </c:pt>
                <c:pt idx="2">
                  <c:v>5.4524323557000001</c:v>
                </c:pt>
                <c:pt idx="3">
                  <c:v>5.0923909840000006</c:v>
                </c:pt>
                <c:pt idx="4">
                  <c:v>8.5564575230000006</c:v>
                </c:pt>
                <c:pt idx="5">
                  <c:v>-2.0860935800000004</c:v>
                </c:pt>
                <c:pt idx="6">
                  <c:v>4.6181166119999997</c:v>
                </c:pt>
                <c:pt idx="7">
                  <c:v>5.01870256000000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C4B-47D3-922B-FF648F27B6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963928"/>
        <c:axId val="168965888"/>
      </c:barChart>
      <c:catAx>
        <c:axId val="1689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965888"/>
        <c:crosses val="autoZero"/>
        <c:auto val="1"/>
        <c:lblAlgn val="ctr"/>
        <c:lblOffset val="100"/>
        <c:noMultiLvlLbl val="0"/>
      </c:catAx>
      <c:valAx>
        <c:axId val="168965888"/>
        <c:scaling>
          <c:orientation val="minMax"/>
          <c:min val="-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LAP-RAP</a:t>
                </a:r>
                <a:r>
                  <a:rPr lang="en-US"/>
                  <a:t> [mm Hg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963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tx>
            <c:v>Left CFTAH 3000 RPM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Y$6,Comparison!$AY$8,Comparison!$AY$10,Comparison!$AY$12,Comparison!$AY$15,Comparison!$AY$17,Comparison!$AY$19,Comparison!$AY$21)</c:f>
              <c:numCache>
                <c:formatCode>0.0</c:formatCode>
                <c:ptCount val="8"/>
                <c:pt idx="0">
                  <c:v>0.96670000000000034</c:v>
                </c:pt>
                <c:pt idx="1">
                  <c:v>2.0146000000000002</c:v>
                </c:pt>
                <c:pt idx="2">
                  <c:v>1.0298999999999996</c:v>
                </c:pt>
                <c:pt idx="3">
                  <c:v>1.1499999999999844E-2</c:v>
                </c:pt>
                <c:pt idx="4">
                  <c:v>1.4773999999999998</c:v>
                </c:pt>
                <c:pt idx="5">
                  <c:v>2.9363999999999999</c:v>
                </c:pt>
                <c:pt idx="6">
                  <c:v>1.4729000000000001</c:v>
                </c:pt>
                <c:pt idx="7">
                  <c:v>0.5041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D25-48BF-8E22-07DEB3F43277}"/>
            </c:ext>
          </c:extLst>
        </c:ser>
        <c:ser>
          <c:idx val="0"/>
          <c:order val="1"/>
          <c:tx>
            <c:v>Left CFTAH 3500 RPM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Y$5,Comparison!$AY$7,Comparison!$AY$9,Comparison!$AY$11,Comparison!$AY$14,Comparison!$AY$16,Comparison!$AY$18,Comparison!$AY$20)</c:f>
              <c:numCache>
                <c:formatCode>0.0</c:formatCode>
                <c:ptCount val="8"/>
                <c:pt idx="0">
                  <c:v>0.46469999999999967</c:v>
                </c:pt>
                <c:pt idx="1">
                  <c:v>1.4541000000000004</c:v>
                </c:pt>
                <c:pt idx="2">
                  <c:v>0.43480000000000008</c:v>
                </c:pt>
                <c:pt idx="3">
                  <c:v>-0.3169000000000004</c:v>
                </c:pt>
                <c:pt idx="4">
                  <c:v>1.1526999999999998</c:v>
                </c:pt>
                <c:pt idx="5">
                  <c:v>2.4287999999999998</c:v>
                </c:pt>
                <c:pt idx="6">
                  <c:v>0.94930000000000048</c:v>
                </c:pt>
                <c:pt idx="7">
                  <c:v>1.529999999999986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D25-48BF-8E22-07DEB3F43277}"/>
            </c:ext>
          </c:extLst>
        </c:ser>
        <c:ser>
          <c:idx val="6"/>
          <c:order val="2"/>
          <c:tx>
            <c:v>Left UVAD 3200/2000 RPM</c:v>
          </c:tx>
          <c:spPr>
            <a:pattFill prst="narHorz">
              <a:fgClr>
                <a:srgbClr val="FF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Y$24,Comparison!$AY$26,Comparison!$AY$28,Comparison!$AY$30,Comparison!$AY$33,Comparison!$AY$35,Comparison!$AY$37,Comparison!$AY$39)</c:f>
              <c:numCache>
                <c:formatCode>0.0</c:formatCode>
                <c:ptCount val="8"/>
                <c:pt idx="0">
                  <c:v>0.3393723129999997</c:v>
                </c:pt>
                <c:pt idx="1">
                  <c:v>1.1827940400000001</c:v>
                </c:pt>
                <c:pt idx="2">
                  <c:v>0.22189725299999985</c:v>
                </c:pt>
                <c:pt idx="3">
                  <c:v>0.14483958799999996</c:v>
                </c:pt>
                <c:pt idx="4">
                  <c:v>0.30973460999999958</c:v>
                </c:pt>
                <c:pt idx="5">
                  <c:v>1.1751871939999998</c:v>
                </c:pt>
                <c:pt idx="6">
                  <c:v>0.24831712000000028</c:v>
                </c:pt>
                <c:pt idx="7">
                  <c:v>-0.215457081999999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D25-48BF-8E22-07DEB3F43277}"/>
            </c:ext>
          </c:extLst>
        </c:ser>
        <c:ser>
          <c:idx val="2"/>
          <c:order val="3"/>
          <c:tx>
            <c:v>Left UVAD 3800/2600 RPM</c:v>
          </c:tx>
          <c:spPr>
            <a:pattFill prst="dkDnDiag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Y$23,Comparison!$AY$25,Comparison!$AY$27,Comparison!$AY$29,Comparison!$AY$32,Comparison!$AY$34,Comparison!$AY$36,Comparison!$AY$38)</c:f>
              <c:numCache>
                <c:formatCode>0.0</c:formatCode>
                <c:ptCount val="8"/>
                <c:pt idx="0">
                  <c:v>-5.409543100000036E-2</c:v>
                </c:pt>
                <c:pt idx="1">
                  <c:v>0.56923137600000029</c:v>
                </c:pt>
                <c:pt idx="2">
                  <c:v>-0.23187487600000001</c:v>
                </c:pt>
                <c:pt idx="3">
                  <c:v>-0.29385510100000012</c:v>
                </c:pt>
                <c:pt idx="4">
                  <c:v>2.4687551000000418E-2</c:v>
                </c:pt>
                <c:pt idx="5">
                  <c:v>0.50564039300000019</c:v>
                </c:pt>
                <c:pt idx="6">
                  <c:v>-0.18386452200000036</c:v>
                </c:pt>
                <c:pt idx="7">
                  <c:v>-0.329891932999999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D25-48BF-8E22-07DEB3F43277}"/>
            </c:ext>
          </c:extLst>
        </c:ser>
        <c:ser>
          <c:idx val="5"/>
          <c:order val="4"/>
          <c:tx>
            <c:v>Right CFTAH 3000 RPM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Z$6,Comparison!$AZ$8,Comparison!$AZ$10,Comparison!$AZ$12,Comparison!$AZ$15,Comparison!$AZ$17,Comparison!$AZ$19,Comparison!$AZ$21)</c:f>
              <c:numCache>
                <c:formatCode>0.0</c:formatCode>
                <c:ptCount val="8"/>
                <c:pt idx="0">
                  <c:v>2.0606000000000004</c:v>
                </c:pt>
                <c:pt idx="1">
                  <c:v>2.3216999999999999</c:v>
                </c:pt>
                <c:pt idx="2">
                  <c:v>1.9156999999999997</c:v>
                </c:pt>
                <c:pt idx="3">
                  <c:v>0.98030000000000017</c:v>
                </c:pt>
                <c:pt idx="4">
                  <c:v>2.4928999999999997</c:v>
                </c:pt>
                <c:pt idx="5">
                  <c:v>2.4713999999999996</c:v>
                </c:pt>
                <c:pt idx="6">
                  <c:v>2.0472000000000001</c:v>
                </c:pt>
                <c:pt idx="7">
                  <c:v>1.16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D25-48BF-8E22-07DEB3F43277}"/>
            </c:ext>
          </c:extLst>
        </c:ser>
        <c:ser>
          <c:idx val="1"/>
          <c:order val="5"/>
          <c:tx>
            <c:v>Right CFTAH 3500 RPM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Z$5,Comparison!$AZ$7,Comparison!$AZ$9,Comparison!$AZ$11,Comparison!$AZ$14,Comparison!$AZ$16,Comparison!$AZ$18,Comparison!$AZ$20)</c:f>
              <c:numCache>
                <c:formatCode>0.0</c:formatCode>
                <c:ptCount val="8"/>
                <c:pt idx="0">
                  <c:v>1.8435000000000001</c:v>
                </c:pt>
                <c:pt idx="1">
                  <c:v>2.1094000000000004</c:v>
                </c:pt>
                <c:pt idx="2">
                  <c:v>1.6589</c:v>
                </c:pt>
                <c:pt idx="3">
                  <c:v>0.78370000000000006</c:v>
                </c:pt>
                <c:pt idx="4">
                  <c:v>2.3026999999999997</c:v>
                </c:pt>
                <c:pt idx="5">
                  <c:v>2.2935999999999996</c:v>
                </c:pt>
                <c:pt idx="6">
                  <c:v>1.7707000000000002</c:v>
                </c:pt>
                <c:pt idx="7">
                  <c:v>0.990499999999999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ED25-48BF-8E22-07DEB3F43277}"/>
            </c:ext>
          </c:extLst>
        </c:ser>
        <c:ser>
          <c:idx val="7"/>
          <c:order val="6"/>
          <c:tx>
            <c:v>Right UVAD 3200/2000 RPM</c:v>
          </c:tx>
          <c:spPr>
            <a:pattFill prst="narHorz">
              <a:fgClr>
                <a:srgbClr val="00B0F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Z$24,Comparison!$AZ$26,Comparison!$AZ$28,Comparison!$AZ$30,Comparison!$AZ$33,Comparison!$AZ$35,Comparison!$AZ$37,Comparison!$AZ$39)</c:f>
              <c:numCache>
                <c:formatCode>0.0</c:formatCode>
                <c:ptCount val="8"/>
                <c:pt idx="0">
                  <c:v>1.4489982239999999</c:v>
                </c:pt>
                <c:pt idx="1">
                  <c:v>1.2486327150000003</c:v>
                </c:pt>
                <c:pt idx="2">
                  <c:v>1.1267660569999998</c:v>
                </c:pt>
                <c:pt idx="3">
                  <c:v>0.82502970999999992</c:v>
                </c:pt>
                <c:pt idx="4">
                  <c:v>2.8305491890000001</c:v>
                </c:pt>
                <c:pt idx="5">
                  <c:v>2.1764714729999999</c:v>
                </c:pt>
                <c:pt idx="6">
                  <c:v>2.0721846350000002</c:v>
                </c:pt>
                <c:pt idx="7">
                  <c:v>1.0782505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ED25-48BF-8E22-07DEB3F43277}"/>
            </c:ext>
          </c:extLst>
        </c:ser>
        <c:ser>
          <c:idx val="3"/>
          <c:order val="7"/>
          <c:tx>
            <c:v>Right UVAD 3800/2600 RPM</c:v>
          </c:tx>
          <c:spPr>
            <a:pattFill prst="dkDnDiag">
              <a:fgClr>
                <a:srgbClr val="0070C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AZ$23,Comparison!$AZ$25,Comparison!$AZ$27,Comparison!$AZ$29,Comparison!$AZ$32,Comparison!$AZ$34,Comparison!$AZ$36,Comparison!$AZ$38)</c:f>
              <c:numCache>
                <c:formatCode>0.0</c:formatCode>
                <c:ptCount val="8"/>
                <c:pt idx="0">
                  <c:v>0.72788773999999989</c:v>
                </c:pt>
                <c:pt idx="1">
                  <c:v>0.49099403700000011</c:v>
                </c:pt>
                <c:pt idx="2">
                  <c:v>0.39100569399999952</c:v>
                </c:pt>
                <c:pt idx="3">
                  <c:v>-5.7547452000000554E-2</c:v>
                </c:pt>
                <c:pt idx="4">
                  <c:v>2.28657069</c:v>
                </c:pt>
                <c:pt idx="5">
                  <c:v>1.622195917</c:v>
                </c:pt>
                <c:pt idx="6">
                  <c:v>1.5130081080000002</c:v>
                </c:pt>
                <c:pt idx="7">
                  <c:v>0.618011838000000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ED25-48BF-8E22-07DEB3F43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588080"/>
        <c:axId val="174592784"/>
      </c:barChart>
      <c:catAx>
        <c:axId val="174588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592784"/>
        <c:crosses val="autoZero"/>
        <c:auto val="1"/>
        <c:lblAlgn val="ctr"/>
        <c:lblOffset val="100"/>
        <c:noMultiLvlLbl val="0"/>
      </c:catAx>
      <c:valAx>
        <c:axId val="174592784"/>
        <c:scaling>
          <c:orientation val="minMax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Flow</a:t>
                </a:r>
                <a:r>
                  <a:rPr lang="en-US" sz="1200"/>
                  <a:t> [LP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588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0"/>
          <c:tx>
            <c:v>Ao. CFTAH 3000 RPM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J$6,Comparison!$J$8,Comparison!$J$10,Comparison!$J$12,Comparison!$J$15,Comparison!$J$17,Comparison!$J$19,Comparison!$J$21)</c:f>
              <c:numCache>
                <c:formatCode>0</c:formatCode>
                <c:ptCount val="8"/>
                <c:pt idx="0">
                  <c:v>52.339299999999994</c:v>
                </c:pt>
                <c:pt idx="1">
                  <c:v>98.845299999999995</c:v>
                </c:pt>
                <c:pt idx="2">
                  <c:v>55.064999999999998</c:v>
                </c:pt>
                <c:pt idx="3">
                  <c:v>12.548099999999991</c:v>
                </c:pt>
                <c:pt idx="4">
                  <c:v>45.320800000000006</c:v>
                </c:pt>
                <c:pt idx="5">
                  <c:v>99.95950000000002</c:v>
                </c:pt>
                <c:pt idx="6">
                  <c:v>46.075299999999999</c:v>
                </c:pt>
                <c:pt idx="7">
                  <c:v>17.9153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96A-44EC-9352-D3D0B30AA336}"/>
            </c:ext>
          </c:extLst>
        </c:ser>
        <c:ser>
          <c:idx val="0"/>
          <c:order val="1"/>
          <c:tx>
            <c:v>Ao. CFTAH 3500 RPM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J$5,Comparison!$J$7,Comparison!$J$9,Comparison!$J$11,Comparison!$J$14,Comparison!$J$16,Comparison!$J$18,Comparison!$J$20)</c:f>
              <c:numCache>
                <c:formatCode>0</c:formatCode>
                <c:ptCount val="8"/>
                <c:pt idx="0">
                  <c:v>39.013400000000004</c:v>
                </c:pt>
                <c:pt idx="1">
                  <c:v>83.854900000000001</c:v>
                </c:pt>
                <c:pt idx="2">
                  <c:v>39.3904</c:v>
                </c:pt>
                <c:pt idx="3">
                  <c:v>9.0666999999999973</c:v>
                </c:pt>
                <c:pt idx="4">
                  <c:v>35.486199999999997</c:v>
                </c:pt>
                <c:pt idx="5">
                  <c:v>85.099399999999989</c:v>
                </c:pt>
                <c:pt idx="6">
                  <c:v>34.797200000000004</c:v>
                </c:pt>
                <c:pt idx="7">
                  <c:v>6.28260000000000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96A-44EC-9352-D3D0B30AA336}"/>
            </c:ext>
          </c:extLst>
        </c:ser>
        <c:ser>
          <c:idx val="6"/>
          <c:order val="2"/>
          <c:tx>
            <c:v>Ao. UVAD 3200/2000 RPM</c:v>
          </c:tx>
          <c:spPr>
            <a:pattFill prst="narHorz">
              <a:fgClr>
                <a:srgbClr val="FF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J$24,Comparison!$J$26,Comparison!$J$28,Comparison!$J$30,Comparison!$J$33,Comparison!$J$35,Comparison!$J$37,Comparison!$J$39)</c:f>
              <c:numCache>
                <c:formatCode>0</c:formatCode>
                <c:ptCount val="8"/>
                <c:pt idx="0">
                  <c:v>59.451718259999993</c:v>
                </c:pt>
                <c:pt idx="1">
                  <c:v>115.29833173</c:v>
                </c:pt>
                <c:pt idx="2">
                  <c:v>60.064786780000006</c:v>
                </c:pt>
                <c:pt idx="3">
                  <c:v>41.424677020000004</c:v>
                </c:pt>
                <c:pt idx="4">
                  <c:v>57.419342060000005</c:v>
                </c:pt>
                <c:pt idx="5">
                  <c:v>113.81279211000002</c:v>
                </c:pt>
                <c:pt idx="6">
                  <c:v>58.107191090000001</c:v>
                </c:pt>
                <c:pt idx="7">
                  <c:v>28.6154465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96A-44EC-9352-D3D0B30AA336}"/>
            </c:ext>
          </c:extLst>
        </c:ser>
        <c:ser>
          <c:idx val="4"/>
          <c:order val="3"/>
          <c:tx>
            <c:v>Ao. UVAD 3800/2600 RPM</c:v>
          </c:tx>
          <c:spPr>
            <a:pattFill prst="dkDnDiag">
              <a:fgClr>
                <a:srgbClr val="C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J$23,Comparison!$J$25,Comparison!$J$27,Comparison!$J$29,Comparison!$J$32,Comparison!$J$34,Comparison!$J$36,Comparison!$J$38)</c:f>
              <c:numCache>
                <c:formatCode>0</c:formatCode>
                <c:ptCount val="8"/>
                <c:pt idx="0">
                  <c:v>53.029235380000003</c:v>
                </c:pt>
                <c:pt idx="1">
                  <c:v>103.95725339000001</c:v>
                </c:pt>
                <c:pt idx="2">
                  <c:v>53.868947320000004</c:v>
                </c:pt>
                <c:pt idx="3">
                  <c:v>30.564072730000007</c:v>
                </c:pt>
                <c:pt idx="4">
                  <c:v>51.436906040000011</c:v>
                </c:pt>
                <c:pt idx="5">
                  <c:v>100.74729248</c:v>
                </c:pt>
                <c:pt idx="6">
                  <c:v>52.181004520000002</c:v>
                </c:pt>
                <c:pt idx="7">
                  <c:v>28.5980891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96A-44EC-9352-D3D0B30AA336}"/>
            </c:ext>
          </c:extLst>
        </c:ser>
        <c:ser>
          <c:idx val="3"/>
          <c:order val="4"/>
          <c:tx>
            <c:v>Pul. CFTAH 3000 RPM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N$6,Comparison!$N$8,Comparison!$N$10,Comparison!$N$12,Comparison!$N$15,Comparison!$N$17,Comparison!$N$19,Comparison!$N$21)</c:f>
              <c:numCache>
                <c:formatCode>0</c:formatCode>
                <c:ptCount val="8"/>
                <c:pt idx="0">
                  <c:v>76.95389999999999</c:v>
                </c:pt>
                <c:pt idx="1">
                  <c:v>65.555499999999995</c:v>
                </c:pt>
                <c:pt idx="2">
                  <c:v>60.931100000000008</c:v>
                </c:pt>
                <c:pt idx="3">
                  <c:v>41.668099999999995</c:v>
                </c:pt>
                <c:pt idx="4">
                  <c:v>82.007899999999992</c:v>
                </c:pt>
                <c:pt idx="5">
                  <c:v>71.162300000000002</c:v>
                </c:pt>
                <c:pt idx="6">
                  <c:v>65.757900000000006</c:v>
                </c:pt>
                <c:pt idx="7">
                  <c:v>47.97719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96A-44EC-9352-D3D0B30AA336}"/>
            </c:ext>
          </c:extLst>
        </c:ser>
        <c:ser>
          <c:idx val="1"/>
          <c:order val="5"/>
          <c:tx>
            <c:v>Pul. CFTAH 3500 RPM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N$5,Comparison!$N$7,Comparison!$N$9,Comparison!$N$11,Comparison!$N$14,Comparison!$N$16,Comparison!$N$18,Comparison!$N$20)</c:f>
              <c:numCache>
                <c:formatCode>0</c:formatCode>
                <c:ptCount val="8"/>
                <c:pt idx="0">
                  <c:v>77.070899999999995</c:v>
                </c:pt>
                <c:pt idx="1">
                  <c:v>65.22999999999999</c:v>
                </c:pt>
                <c:pt idx="2">
                  <c:v>60.546700000000001</c:v>
                </c:pt>
                <c:pt idx="3">
                  <c:v>39.4983</c:v>
                </c:pt>
                <c:pt idx="4">
                  <c:v>81.965099999999993</c:v>
                </c:pt>
                <c:pt idx="5">
                  <c:v>70.5214</c:v>
                </c:pt>
                <c:pt idx="6">
                  <c:v>64.286500000000004</c:v>
                </c:pt>
                <c:pt idx="7">
                  <c:v>44.4264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F96A-44EC-9352-D3D0B30AA336}"/>
            </c:ext>
          </c:extLst>
        </c:ser>
        <c:ser>
          <c:idx val="7"/>
          <c:order val="6"/>
          <c:tx>
            <c:v>Pul. UVAD 3200/2000 RPM</c:v>
          </c:tx>
          <c:spPr>
            <a:pattFill prst="narHorz">
              <a:fgClr>
                <a:srgbClr val="00B0F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N$24,Comparison!$N$26,Comparison!$N$28,Comparison!$N$30,Comparison!$N$33,Comparison!$N$35,Comparison!$N$37,Comparison!$N$39)</c:f>
              <c:numCache>
                <c:formatCode>0</c:formatCode>
                <c:ptCount val="8"/>
                <c:pt idx="0">
                  <c:v>81.794736489999991</c:v>
                </c:pt>
                <c:pt idx="1">
                  <c:v>66.064674757999995</c:v>
                </c:pt>
                <c:pt idx="2">
                  <c:v>59.936029180000006</c:v>
                </c:pt>
                <c:pt idx="3">
                  <c:v>52.554391710000004</c:v>
                </c:pt>
                <c:pt idx="4">
                  <c:v>82.588451113000005</c:v>
                </c:pt>
                <c:pt idx="5">
                  <c:v>73.341820834000004</c:v>
                </c:pt>
                <c:pt idx="6">
                  <c:v>70.797984224999993</c:v>
                </c:pt>
                <c:pt idx="7">
                  <c:v>48.332027134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96A-44EC-9352-D3D0B30AA336}"/>
            </c:ext>
          </c:extLst>
        </c:ser>
        <c:ser>
          <c:idx val="5"/>
          <c:order val="7"/>
          <c:tx>
            <c:v>Pul. UVAD 3800/2600 RPM</c:v>
          </c:tx>
          <c:spPr>
            <a:pattFill prst="dkDnDiag">
              <a:fgClr>
                <a:srgbClr val="0070C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Lit>
              <c:ptCount val="8"/>
              <c:pt idx="0">
                <c:v>LHF (VC)</c:v>
              </c:pt>
              <c:pt idx="1">
                <c:v>RHF (VC)</c:v>
              </c:pt>
              <c:pt idx="2">
                <c:v>BHF (VC)</c:v>
              </c:pt>
              <c:pt idx="3">
                <c:v>Severe BHF (VC)</c:v>
              </c:pt>
              <c:pt idx="4">
                <c:v>LHF (AC)</c:v>
              </c:pt>
              <c:pt idx="5">
                <c:v>RHF (AC)</c:v>
              </c:pt>
              <c:pt idx="6">
                <c:v>BHF (AC)</c:v>
              </c:pt>
              <c:pt idx="7">
                <c:v>Severe BHF (AC)</c:v>
              </c:pt>
            </c:strLit>
          </c:cat>
          <c:val>
            <c:numRef>
              <c:f>(Comparison!$N$23,Comparison!$N$25,Comparison!$N$27,Comparison!$N$29,Comparison!$N$32,Comparison!$N$34,Comparison!$N$36,Comparison!$N$38)</c:f>
              <c:numCache>
                <c:formatCode>0</c:formatCode>
                <c:ptCount val="8"/>
                <c:pt idx="0">
                  <c:v>80.639881490000008</c:v>
                </c:pt>
                <c:pt idx="1">
                  <c:v>57.862717230000001</c:v>
                </c:pt>
                <c:pt idx="2">
                  <c:v>53.380131939999998</c:v>
                </c:pt>
                <c:pt idx="3">
                  <c:v>29.365019669999995</c:v>
                </c:pt>
                <c:pt idx="4">
                  <c:v>80.714863780000002</c:v>
                </c:pt>
                <c:pt idx="5">
                  <c:v>68.622715389999996</c:v>
                </c:pt>
                <c:pt idx="6">
                  <c:v>65.95683944000001</c:v>
                </c:pt>
                <c:pt idx="7">
                  <c:v>37.95004208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F96A-44EC-9352-D3D0B30AA3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593960"/>
        <c:axId val="174588864"/>
      </c:barChart>
      <c:catAx>
        <c:axId val="174593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588864"/>
        <c:crosses val="autoZero"/>
        <c:auto val="1"/>
        <c:lblAlgn val="ctr"/>
        <c:lblOffset val="100"/>
        <c:noMultiLvlLbl val="0"/>
      </c:catAx>
      <c:valAx>
        <c:axId val="174588864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Max - Min </a:t>
                </a:r>
                <a:r>
                  <a:rPr lang="en-US"/>
                  <a:t>[mm Hg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593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8E2821-5405-4E1B-BE28-2F80B0F2D079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318775-A721-45F7-9C21-A332BA9A46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359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318775-A721-45F7-9C21-A332BA9A467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0086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318775-A721-45F7-9C21-A332BA9A467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3369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318775-A721-45F7-9C21-A332BA9A467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06D8FD2-4EBC-430C-9292-0A906FFC46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2698ADC3-186A-4DF3-9887-C8E050BF41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380842A-AF2D-47AB-BBBC-841DF17E8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5651A18-0EC5-4A09-8BAE-CDA84C2DD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E5F67B0-70B7-4E2A-85AF-5F9AA6E6F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940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32FEACD-8C1B-44F4-8AB8-08ACDFBD1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885E049-9582-494F-81EF-F85F905D2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D396E3-A992-428D-A001-20650CB9D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21E502-A4E8-4E98-9198-FD7A2FF1F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6134F67-E0ED-47E3-AA55-F586C7F37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442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FA83305-BE71-42BC-AC1C-3D5674DDF8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757AF3C-974F-4436-8896-562D812669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0A6B714-4EB0-4D2F-81F4-32C7AB58A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D52D1C6-6F37-46C8-843B-530313B08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8965712-F5F7-4732-A6D5-F0FCF173D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765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7C0BBBE-C433-48F3-9765-90F50F468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B39DBB4-941E-449A-AB13-8E27F63A72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34A86CB-3F93-4C09-9690-A0A779F72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792DC6D-6E76-4B05-87FE-55B1B7D2A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F8ED2E9-6CC0-44E8-83A1-9FF19D5FE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472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7C1A305-F337-4CBB-A3E9-0B79B9D2D4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D2D8432-705D-403D-8C49-E2CE522737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63588B-3DA2-4DD1-861C-78177070E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28FFB8D-BF5F-41BE-B517-EA1CA102F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3B4525A-4A58-48D4-AD15-402506E0F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354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CAB2D34-D2F1-469B-8457-5169B916A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4D3D0D8-9026-4EC2-AC7F-E9E23E850F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BAAA251-925E-48AC-B77B-A40577E246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818DB03-87AC-463A-B12D-435F63120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8D19899-26FF-4A17-A397-65F9F41A2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1C4C6A6-24AE-4233-99E2-E23C20C29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25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39B4075-2030-4155-B3C6-E8722CCCE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A4D95F4-43D9-402C-8450-7C4A2F2169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CD4B1A0-26C1-4DA0-814F-80D24462A6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2EB85E4-0638-41FE-953A-DA46A28941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43452AC-411B-4EE3-BA70-0235027C09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D3BE232-7503-4502-9140-7C8D76E02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8D79CE5-194E-462F-AEF8-1E5453E19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07875DC-867F-424E-9628-CA211F357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80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CEC4073-210A-48E1-A2C3-EE8ADC080A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2F00CB8-CC5C-455E-BDB5-0A26C590E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89AD059-8435-4A27-A36B-5052FDE08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E9C5365-2856-448D-AC31-DC2ECAC4C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775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9E8934B2-8509-4FE2-BEF7-EAA35900E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6D8056D-4F7E-4822-A174-5686A577C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FCE3C79-BDDD-416E-8ACA-FAF04DAB2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917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5B043FF-16BD-4E30-9F4F-41F1A5D191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C75B8EC-133B-4829-AE93-9313707926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FEA4E38-EF5A-4182-8147-9D71565EE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CD04279-E23F-429E-8D6F-29DA01C52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3BB370F-5EAB-4B6F-8901-F897A7F54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5D7CBF2-86C2-4106-B94C-ED3BD0FCD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268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F007193-04C7-4FB3-AEA4-EACFB9EE0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9B330CB-C90C-4047-A16A-D9DA564EFB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C9D925B-4657-448E-96A8-BECB440608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136E529-9F05-4425-B0C2-4C8304514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019D5A5-677F-4DAE-8C3A-612E2A894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D6EB5B7-436B-4998-917A-A236E8DEB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546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41D9D118-85C7-4FFF-8E19-A15BBA30CF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0B704E7-4023-424C-8BC1-EB883459A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E255924-2D80-465C-A7D5-34D2285160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EE5D1-AA90-4718-85E2-26FA9C959DC8}" type="datetimeFigureOut">
              <a:rPr lang="en-US" smtClean="0"/>
              <a:t>2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C9F7E11-2AEB-4F40-9FF1-2BCA086D5B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A54D688-EA7E-4253-8961-805836F47B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DE08C-C240-45C6-A5E7-DEAF0CAB4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57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7C3C71DF-610A-45C9-82AF-E9E57A79C6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8559400"/>
              </p:ext>
            </p:extLst>
          </p:nvPr>
        </p:nvGraphicFramePr>
        <p:xfrm>
          <a:off x="1524000" y="684609"/>
          <a:ext cx="9144000" cy="5488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0"/>
            <a:ext cx="26937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740454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6937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2</a:t>
            </a:r>
            <a:endParaRPr lang="en-US"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xmlns="" id="{37CBF2E3-64DF-4EBC-A70D-FDB0D70F5C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1925191"/>
              </p:ext>
            </p:extLst>
          </p:nvPr>
        </p:nvGraphicFramePr>
        <p:xfrm>
          <a:off x="1524000" y="585132"/>
          <a:ext cx="9144000" cy="54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901805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6937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3</a:t>
            </a:r>
            <a:endParaRPr lang="en-US" dirty="0"/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xmlns="" id="{B75849B7-FF1B-4E92-9735-F7663C0878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9878612"/>
              </p:ext>
            </p:extLst>
          </p:nvPr>
        </p:nvGraphicFramePr>
        <p:xfrm>
          <a:off x="1524000" y="524999"/>
          <a:ext cx="9144000" cy="54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028595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80</TotalTime>
  <Words>28</Words>
  <Application>Microsoft Office PowerPoint</Application>
  <PresentationFormat>Widescreen</PresentationFormat>
  <Paragraphs>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nis</dc:creator>
  <cp:lastModifiedBy>Karimov, Jamshid</cp:lastModifiedBy>
  <cp:revision>75</cp:revision>
  <dcterms:created xsi:type="dcterms:W3CDTF">2021-10-10T17:11:19Z</dcterms:created>
  <dcterms:modified xsi:type="dcterms:W3CDTF">2023-02-06T19:12:06Z</dcterms:modified>
</cp:coreProperties>
</file>